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755967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188" autoAdjust="0"/>
  </p:normalViewPr>
  <p:slideViewPr>
    <p:cSldViewPr snapToGrid="0">
      <p:cViewPr varScale="1">
        <p:scale>
          <a:sx n="55" d="100"/>
          <a:sy n="55" d="100"/>
        </p:scale>
        <p:origin x="107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37197"/>
            <a:ext cx="9144000" cy="263188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970580"/>
            <a:ext cx="9144000" cy="1825171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1638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739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02483"/>
            <a:ext cx="2628900" cy="640647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02483"/>
            <a:ext cx="7734300" cy="640647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833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412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884670"/>
            <a:ext cx="10515600" cy="314461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059034"/>
            <a:ext cx="10515600" cy="165367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906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12414"/>
            <a:ext cx="5181600" cy="479654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12414"/>
            <a:ext cx="5181600" cy="479654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6110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02483"/>
            <a:ext cx="10515600" cy="146118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853171"/>
            <a:ext cx="5157787" cy="90821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761381"/>
            <a:ext cx="5157787" cy="406157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853171"/>
            <a:ext cx="5183188" cy="90821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761381"/>
            <a:ext cx="5183188" cy="406157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7346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813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4567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03978"/>
            <a:ext cx="3932237" cy="1763924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88454"/>
            <a:ext cx="6172200" cy="537226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67902"/>
            <a:ext cx="3932237" cy="420157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3271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03978"/>
            <a:ext cx="3932237" cy="1763924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88454"/>
            <a:ext cx="6172200" cy="537226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67902"/>
            <a:ext cx="3932237" cy="420157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575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02483"/>
            <a:ext cx="10515600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12414"/>
            <a:ext cx="10515600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006699"/>
            <a:ext cx="27432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5853C-5DEA-42A7-919F-78F2387D33B4}" type="datetimeFigureOut">
              <a:rPr lang="zh-CN" altLang="en-US" smtClean="0"/>
              <a:t>2021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006699"/>
            <a:ext cx="41148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006699"/>
            <a:ext cx="2743200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27484-0064-4418-9A4C-13644A8181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0449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647273" y="585036"/>
            <a:ext cx="9353919" cy="99145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chemeClr val="tx1"/>
                </a:solidFill>
              </a:rPr>
              <a:t>Singleton pregnant </a:t>
            </a:r>
            <a:r>
              <a:rPr lang="en-US" altLang="zh-CN" dirty="0">
                <a:solidFill>
                  <a:schemeClr val="tx1"/>
                </a:solidFill>
              </a:rPr>
              <a:t>women aged 18-50 years at 8-12 weeks of gestation in the Beijing Obstetrics and Gynecology Hospital, 2016-2019</a:t>
            </a:r>
          </a:p>
          <a:p>
            <a:pPr algn="ctr"/>
            <a:r>
              <a:rPr lang="en-US" altLang="zh-CN" dirty="0">
                <a:solidFill>
                  <a:schemeClr val="tx1"/>
                </a:solidFill>
              </a:rPr>
              <a:t>(n=38,003) </a:t>
            </a:r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5" name="矩形 4"/>
          <p:cNvSpPr/>
          <p:nvPr/>
        </p:nvSpPr>
        <p:spPr>
          <a:xfrm>
            <a:off x="4452424" y="1815365"/>
            <a:ext cx="5880098" cy="58997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 err="1">
                <a:solidFill>
                  <a:schemeClr val="tx1"/>
                </a:solidFill>
              </a:rPr>
              <a:t>Primiparas</a:t>
            </a:r>
            <a:r>
              <a:rPr lang="en-US" altLang="zh-CN" dirty="0">
                <a:solidFill>
                  <a:schemeClr val="tx1"/>
                </a:solidFill>
              </a:rPr>
              <a:t>(n=27</a:t>
            </a:r>
            <a:r>
              <a:rPr lang="en-US" altLang="zh-CN" dirty="0">
                <a:solidFill>
                  <a:schemeClr val="tx1"/>
                </a:solidFill>
              </a:rPr>
              <a:t>,</a:t>
            </a:r>
            <a:r>
              <a:rPr lang="en-US" altLang="zh-CN" dirty="0">
                <a:solidFill>
                  <a:schemeClr val="tx1"/>
                </a:solidFill>
              </a:rPr>
              <a:t>618)</a:t>
            </a:r>
            <a:endParaRPr lang="zh-CN" altLang="en-US" dirty="0">
              <a:solidFill>
                <a:schemeClr val="tx1"/>
              </a:solidFill>
            </a:endParaRPr>
          </a:p>
        </p:txBody>
      </p:sp>
      <p:cxnSp>
        <p:nvCxnSpPr>
          <p:cNvPr id="7" name="直接箭头连接符 6"/>
          <p:cNvCxnSpPr/>
          <p:nvPr/>
        </p:nvCxnSpPr>
        <p:spPr>
          <a:xfrm>
            <a:off x="3873950" y="1571126"/>
            <a:ext cx="8063" cy="101292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>
            <a:off x="3882012" y="2126289"/>
            <a:ext cx="5704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矩形 13"/>
          <p:cNvSpPr/>
          <p:nvPr/>
        </p:nvSpPr>
        <p:spPr>
          <a:xfrm>
            <a:off x="2698181" y="4401189"/>
            <a:ext cx="9303010" cy="54065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5845871" y="4505949"/>
            <a:ext cx="34027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Women with live birth (n=10,151) </a:t>
            </a:r>
            <a:endParaRPr lang="zh-CN" altLang="en-US" dirty="0"/>
          </a:p>
        </p:txBody>
      </p:sp>
      <p:sp>
        <p:nvSpPr>
          <p:cNvPr id="16" name="矩形 15"/>
          <p:cNvSpPr/>
          <p:nvPr/>
        </p:nvSpPr>
        <p:spPr>
          <a:xfrm>
            <a:off x="2629444" y="2603633"/>
            <a:ext cx="9353919" cy="62232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chemeClr val="tx1"/>
                </a:solidFill>
              </a:rPr>
              <a:t>Multiparas (n=10,385) </a:t>
            </a:r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4463062" y="3413722"/>
            <a:ext cx="5880098" cy="72472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chemeClr val="tx1"/>
                </a:solidFill>
              </a:rPr>
              <a:t>Abortion (n=216), </a:t>
            </a:r>
            <a:r>
              <a:rPr lang="en-US" altLang="zh-CN" dirty="0">
                <a:solidFill>
                  <a:schemeClr val="tx1"/>
                </a:solidFill>
              </a:rPr>
              <a:t>Stillbirth </a:t>
            </a:r>
            <a:r>
              <a:rPr lang="en-US" altLang="zh-CN" dirty="0">
                <a:solidFill>
                  <a:schemeClr val="tx1"/>
                </a:solidFill>
              </a:rPr>
              <a:t>(n=33), </a:t>
            </a:r>
            <a:r>
              <a:rPr lang="en-US" altLang="zh-CN" dirty="0">
                <a:solidFill>
                  <a:schemeClr val="tx1"/>
                </a:solidFill>
              </a:rPr>
              <a:t>Medical abortion due to fetal </a:t>
            </a:r>
            <a:r>
              <a:rPr lang="en-US" altLang="zh-CN" dirty="0">
                <a:solidFill>
                  <a:schemeClr val="tx1"/>
                </a:solidFill>
              </a:rPr>
              <a:t>malformation (n=138)</a:t>
            </a:r>
          </a:p>
        </p:txBody>
      </p:sp>
      <p:cxnSp>
        <p:nvCxnSpPr>
          <p:cNvPr id="18" name="直接箭头连接符 17"/>
          <p:cNvCxnSpPr/>
          <p:nvPr/>
        </p:nvCxnSpPr>
        <p:spPr>
          <a:xfrm>
            <a:off x="3873949" y="3232853"/>
            <a:ext cx="0" cy="11789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>
            <a:off x="3892650" y="3745590"/>
            <a:ext cx="5704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1" y="163361"/>
            <a:ext cx="41203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Supplementary Figure 1. Study flow chart.</a:t>
            </a:r>
            <a:endParaRPr lang="zh-CN" altLang="zh-CN" dirty="0"/>
          </a:p>
        </p:txBody>
      </p:sp>
      <p:sp>
        <p:nvSpPr>
          <p:cNvPr id="20" name="矩形 19"/>
          <p:cNvSpPr/>
          <p:nvPr/>
        </p:nvSpPr>
        <p:spPr>
          <a:xfrm>
            <a:off x="3916439" y="6553092"/>
            <a:ext cx="2836674" cy="73248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rgbClr val="FF0000"/>
                </a:solidFill>
              </a:rPr>
              <a:t>GDM history </a:t>
            </a:r>
            <a:r>
              <a:rPr lang="en-US" altLang="zh-CN" dirty="0">
                <a:solidFill>
                  <a:srgbClr val="FF0000"/>
                </a:solidFill>
              </a:rPr>
              <a:t>(n=806)</a:t>
            </a:r>
            <a:endParaRPr lang="en-US" altLang="zh-CN" dirty="0">
              <a:solidFill>
                <a:srgbClr val="FF0000"/>
              </a:solidFill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7917326" y="6587193"/>
            <a:ext cx="2728639" cy="73248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rgbClr val="FF0000"/>
                </a:solidFill>
              </a:rPr>
              <a:t>No GDM history</a:t>
            </a:r>
          </a:p>
          <a:p>
            <a:pPr algn="ctr"/>
            <a:r>
              <a:rPr lang="en-US" altLang="zh-CN" dirty="0">
                <a:solidFill>
                  <a:srgbClr val="FF0000"/>
                </a:solidFill>
              </a:rPr>
              <a:t>(</a:t>
            </a:r>
            <a:r>
              <a:rPr lang="en-US" altLang="zh-CN" dirty="0">
                <a:solidFill>
                  <a:srgbClr val="FF0000"/>
                </a:solidFill>
              </a:rPr>
              <a:t>n=9,230)</a:t>
            </a:r>
            <a:endParaRPr lang="en-US" altLang="zh-CN" dirty="0">
              <a:solidFill>
                <a:srgbClr val="FF0000"/>
              </a:solidFill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2698181" y="6057174"/>
            <a:ext cx="9303010" cy="134277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4642105" y="6104060"/>
            <a:ext cx="53342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Women included in the risk factor analyses (n=10,036) 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4463062" y="5124333"/>
            <a:ext cx="5880098" cy="72472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rgbClr val="FF0000"/>
                </a:solidFill>
              </a:rPr>
              <a:t>Women with pre-gestational diabetes mellitus (n=115)</a:t>
            </a:r>
          </a:p>
        </p:txBody>
      </p:sp>
      <p:cxnSp>
        <p:nvCxnSpPr>
          <p:cNvPr id="25" name="直接箭头连接符 24"/>
          <p:cNvCxnSpPr/>
          <p:nvPr/>
        </p:nvCxnSpPr>
        <p:spPr>
          <a:xfrm>
            <a:off x="3873949" y="4943464"/>
            <a:ext cx="0" cy="11137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>
            <a:off x="3892650" y="5456201"/>
            <a:ext cx="57041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05686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4</TotalTime>
  <Words>90</Words>
  <Application>Microsoft Office PowerPoint</Application>
  <PresentationFormat>自定义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w</dc:creator>
  <cp:lastModifiedBy>zw</cp:lastModifiedBy>
  <cp:revision>24</cp:revision>
  <dcterms:created xsi:type="dcterms:W3CDTF">2020-02-07T02:34:54Z</dcterms:created>
  <dcterms:modified xsi:type="dcterms:W3CDTF">2021-10-24T02:03:10Z</dcterms:modified>
</cp:coreProperties>
</file>